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432" r:id="rId2"/>
    <p:sldId id="414" r:id="rId3"/>
    <p:sldId id="415" r:id="rId4"/>
    <p:sldId id="403" r:id="rId5"/>
    <p:sldId id="43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E44CC6-385E-6443-ACE3-9C3EE7F178F7}" type="datetimeFigureOut">
              <a:rPr lang="en-US" smtClean="0"/>
              <a:t>8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D6549A-1423-7740-B215-A289EE840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137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Landlocked site showing roads on all side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78B179-CE36-0D48-8124-324B019183F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8056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y 2021, Jody’s data (mid marsh site), Higher at the aggregate edge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78B179-CE36-0D48-8124-324B019183F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497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A5A0E-A429-B9A8-134C-29E09F563D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FE0B52-5603-F084-A6B3-D8B57A9853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D0DD1-489D-A550-0BE3-46D22B412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5FAB78-6375-7B10-7FEB-3E2E77C10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A37D0-D78F-463E-B39E-B61A23FF6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004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822034-4591-A797-E576-9B76D442D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4923A2-160F-8F0F-3931-37907F7675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E685F6-138E-3B17-4B65-C9F44C2CC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325ACE-171E-BDB7-2A89-A3002E27B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A723A-3CE2-118C-5913-842FAC146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03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75BA54-4471-E717-36E3-F91A306B3A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0B27C1-620F-5DF8-2ED7-99029AF145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EDEBDF-434D-B3B7-470A-2734317A1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85FE90-5BC9-7643-1B9C-22665BEB7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2C306D-47FB-67E6-A2D2-5F5BD381F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93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ADE866-1A4A-50FE-5861-F6B5F3E70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726251-254E-6746-4498-5F190F8910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84C541-71BB-E8A8-3D03-D8771691A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555D43-7955-3B91-2DF2-E3E10B87F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92BFE1-A34E-DB2C-B342-F069C7725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827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1DDA00-6C9A-7CD2-F8E3-8017CA61C9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7C82BA-4DBC-5C15-CDCF-AE82AF943F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DDE110-059E-215B-3AC6-8E03E507C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E8B191-8627-26C7-B9BE-0986D6D99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CC01B3-1C6C-C527-7B0D-1C5E81556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136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BABF32-0444-37DA-4628-AAE42B39DB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7BE03F-B2D1-28AA-A943-1F7E67085C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166ADA-1ADE-9CE2-A5A9-2F26A0540E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CDA28A-B38D-C6B8-BF35-09539CE9A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0E4977-F812-8162-EB33-3AFEE492B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A6BCB8-856D-54DB-7FFA-35037C1F6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111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FCA913-95CF-2A5E-DA74-F705FDC8C4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606B0B-67DA-6550-A85B-F3D1CF2D36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F85DD2-8B7B-9A5E-4F12-3703061F58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3B1DFB-0916-5A0A-C322-F87621F7E5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7C3423-9875-998D-5BA6-AE1E36E55D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27BC21-51D5-0728-6C2A-0E94649B28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F6C3D7-E10E-68C2-610D-5CBA7D5B0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D72672-04CC-FCDC-15BB-FD23780D1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338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3684D5-D401-116A-4C18-7C1662F3E5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BFC336-EF4B-AC7D-D23A-7E3E35EA0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B217D7-0049-90BC-4F37-6BCDB28B9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771993-E6A4-3C96-CEAE-6C5536AEA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979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A001A3-37B0-167A-FE94-53B87A7D3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28E447-537D-3E54-D3FF-DD8CF4C71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7A82AD-B1DD-263B-0B14-B5EA28586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697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C4652-CF68-A7D7-F34C-6845489EC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C287BC-1EAE-2EB8-B007-7706B1F4EE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0CEB14-FCB0-1054-15E1-1DBC521891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AEC590-CBE2-261C-2D08-A5CB8CA1B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01490D-1069-4298-586A-28B829B49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176D03-5A27-E841-2FA6-CDB84938E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208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9CFC24-0597-9B23-86ED-CBB9A29DB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5510A19-DA59-EEFC-F437-90F6A97546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71C627-BE76-7161-61B2-2FD01FE2F0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3AE111-AE6B-A4D9-D147-0FF14950FC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483A05-E9BF-E593-7895-57B236BA5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B310B4-798C-48AD-88A6-2EA12819D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8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34BAB1-D78B-AD09-09A5-DC64F925F4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FE3BD6-AB25-5BD7-8777-DC42E0AF3B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020FA-12EC-12E8-7264-ADAFA7CE0B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FCCD0-38D4-9A4D-9D5E-51FF963254DE}" type="datetimeFigureOut">
              <a:rPr lang="en-US" smtClean="0"/>
              <a:t>8/1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A691B1-A0A1-7130-53B4-3A23E0A372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C30501-DEFA-BFBA-B4B2-617073A7A7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D871A-B6D5-A14E-8C02-5AA4215BC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99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A4B3E-2F67-2241-518B-4765D165D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49284" y="2373034"/>
            <a:ext cx="10515600" cy="1325563"/>
          </a:xfrm>
        </p:spPr>
        <p:txBody>
          <a:bodyPr/>
          <a:lstStyle/>
          <a:p>
            <a:r>
              <a:rPr lang="en-US" dirty="0"/>
              <a:t>Supplementary figures</a:t>
            </a:r>
            <a:br>
              <a:rPr lang="en-US" dirty="0"/>
            </a:br>
            <a:r>
              <a:rPr lang="en-US" dirty="0"/>
              <a:t>1-3, 5</a:t>
            </a:r>
          </a:p>
        </p:txBody>
      </p:sp>
    </p:spTree>
    <p:extLst>
      <p:ext uri="{BB962C8B-B14F-4D97-AF65-F5344CB8AC3E}">
        <p14:creationId xmlns:p14="http://schemas.microsoft.com/office/powerpoint/2010/main" val="2753312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>
            <a:extLst>
              <a:ext uri="{FF2B5EF4-FFF2-40B4-BE49-F238E27FC236}">
                <a16:creationId xmlns:a16="http://schemas.microsoft.com/office/drawing/2014/main" id="{7945FC63-7287-0457-3F57-E2EB42D04E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49003" y="1089467"/>
            <a:ext cx="7293360" cy="532229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C757979-E0F0-2707-5501-F7CF9A3C3506}"/>
              </a:ext>
            </a:extLst>
          </p:cNvPr>
          <p:cNvSpPr txBox="1"/>
          <p:nvPr/>
        </p:nvSpPr>
        <p:spPr>
          <a:xfrm>
            <a:off x="2176724" y="446237"/>
            <a:ext cx="83768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: Landlocked site showing roads on all sides</a:t>
            </a:r>
          </a:p>
        </p:txBody>
      </p:sp>
    </p:spTree>
    <p:extLst>
      <p:ext uri="{BB962C8B-B14F-4D97-AF65-F5344CB8AC3E}">
        <p14:creationId xmlns:p14="http://schemas.microsoft.com/office/powerpoint/2010/main" val="1691366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9EA3BB5-2AEB-D63C-FF0E-00B728FB655D}"/>
              </a:ext>
            </a:extLst>
          </p:cNvPr>
          <p:cNvSpPr txBox="1"/>
          <p:nvPr/>
        </p:nvSpPr>
        <p:spPr>
          <a:xfrm>
            <a:off x="2117558" y="363111"/>
            <a:ext cx="7927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2:  Set-up for mussel heart rate measurements.</a:t>
            </a:r>
          </a:p>
        </p:txBody>
      </p:sp>
      <p:pic>
        <p:nvPicPr>
          <p:cNvPr id="2" name="image8.png" descr="A picture containing text, electronics, computer&#10;&#10;Description automatically generated">
            <a:extLst>
              <a:ext uri="{FF2B5EF4-FFF2-40B4-BE49-F238E27FC236}">
                <a16:creationId xmlns:a16="http://schemas.microsoft.com/office/drawing/2014/main" id="{2390C3A9-7551-52F4-DC3C-3978ACA505A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065007" y="1458150"/>
            <a:ext cx="10334513" cy="3888401"/>
          </a:xfrm>
          <a:prstGeom prst="rect">
            <a:avLst/>
          </a:prstGeom>
          <a:ln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430039D-70E4-EC09-8492-AA16673AA5EC}"/>
              </a:ext>
            </a:extLst>
          </p:cNvPr>
          <p:cNvSpPr txBox="1"/>
          <p:nvPr/>
        </p:nvSpPr>
        <p:spPr>
          <a:xfrm>
            <a:off x="4525350" y="5067311"/>
            <a:ext cx="1645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schemeClr val="bg1"/>
                </a:solidFill>
              </a:rPr>
              <a:t>Picoscope</a:t>
            </a:r>
            <a:r>
              <a:rPr lang="en-US" dirty="0">
                <a:solidFill>
                  <a:schemeClr val="bg1"/>
                </a:solidFill>
              </a:rPr>
              <a:t> 202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BC42F2-BB04-A064-F228-7BEC60C92C18}"/>
              </a:ext>
            </a:extLst>
          </p:cNvPr>
          <p:cNvSpPr txBox="1"/>
          <p:nvPr/>
        </p:nvSpPr>
        <p:spPr>
          <a:xfrm>
            <a:off x="6996023" y="5067311"/>
            <a:ext cx="1645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mplifie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D6B1846-4E93-5F45-CE54-F9AAAB432604}"/>
              </a:ext>
            </a:extLst>
          </p:cNvPr>
          <p:cNvSpPr txBox="1"/>
          <p:nvPr/>
        </p:nvSpPr>
        <p:spPr>
          <a:xfrm>
            <a:off x="9074527" y="4790312"/>
            <a:ext cx="26248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ussel and Sensor covered with </a:t>
            </a:r>
            <a:r>
              <a:rPr lang="en-US" dirty="0" err="1">
                <a:solidFill>
                  <a:schemeClr val="bg1"/>
                </a:solidFill>
              </a:rPr>
              <a:t>blueTac</a:t>
            </a:r>
            <a:endParaRPr lang="en-US" dirty="0">
              <a:solidFill>
                <a:schemeClr val="bg1"/>
              </a:solidFill>
            </a:endParaRP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B8D07DEF-63CD-82A1-9E0D-554909F9B141}"/>
              </a:ext>
            </a:extLst>
          </p:cNvPr>
          <p:cNvCxnSpPr>
            <a:cxnSpLocks/>
          </p:cNvCxnSpPr>
          <p:nvPr/>
        </p:nvCxnSpPr>
        <p:spPr>
          <a:xfrm flipV="1">
            <a:off x="7426379" y="4768333"/>
            <a:ext cx="112938" cy="26975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8F8E67FB-76CB-414A-DE2E-D850F0DDAAC3}"/>
              </a:ext>
            </a:extLst>
          </p:cNvPr>
          <p:cNvCxnSpPr>
            <a:cxnSpLocks/>
          </p:cNvCxnSpPr>
          <p:nvPr/>
        </p:nvCxnSpPr>
        <p:spPr>
          <a:xfrm flipV="1">
            <a:off x="9466696" y="3943179"/>
            <a:ext cx="188242" cy="96002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2F0DB689-0D16-3ACB-08B0-47FA8F29C2E5}"/>
              </a:ext>
            </a:extLst>
          </p:cNvPr>
          <p:cNvCxnSpPr>
            <a:cxnSpLocks/>
          </p:cNvCxnSpPr>
          <p:nvPr/>
        </p:nvCxnSpPr>
        <p:spPr>
          <a:xfrm flipH="1" flipV="1">
            <a:off x="10239487" y="2697084"/>
            <a:ext cx="389068" cy="2206124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FCCBECDB-DCA0-DC92-CD60-CCD3A4584319}"/>
              </a:ext>
            </a:extLst>
          </p:cNvPr>
          <p:cNvCxnSpPr>
            <a:cxnSpLocks/>
          </p:cNvCxnSpPr>
          <p:nvPr/>
        </p:nvCxnSpPr>
        <p:spPr>
          <a:xfrm flipV="1">
            <a:off x="5235372" y="4663036"/>
            <a:ext cx="112938" cy="26975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476977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 descr="A screenshot of a graph&#10;&#10;Description automatically generated with medium confidence">
            <a:extLst>
              <a:ext uri="{FF2B5EF4-FFF2-40B4-BE49-F238E27FC236}">
                <a16:creationId xmlns:a16="http://schemas.microsoft.com/office/drawing/2014/main" id="{34B7917F-D784-3E5B-E401-7CE09AD613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420" y="745298"/>
            <a:ext cx="6150028" cy="4476440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EF8FDFB4-48B4-7DC3-AB3A-F62CBA42E61A}"/>
              </a:ext>
            </a:extLst>
          </p:cNvPr>
          <p:cNvCxnSpPr>
            <a:cxnSpLocks/>
          </p:cNvCxnSpPr>
          <p:nvPr/>
        </p:nvCxnSpPr>
        <p:spPr>
          <a:xfrm>
            <a:off x="3388650" y="745298"/>
            <a:ext cx="0" cy="447644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8A45437A-4115-417E-F90E-862612D37BEC}"/>
              </a:ext>
            </a:extLst>
          </p:cNvPr>
          <p:cNvSpPr txBox="1"/>
          <p:nvPr/>
        </p:nvSpPr>
        <p:spPr>
          <a:xfrm rot="16200000">
            <a:off x="-3509894" y="904620"/>
            <a:ext cx="74814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ussel Body Temperature (°C)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1FB5DB63-423A-2C51-A982-D823D56241D2}"/>
              </a:ext>
            </a:extLst>
          </p:cNvPr>
          <p:cNvCxnSpPr>
            <a:cxnSpLocks/>
          </p:cNvCxnSpPr>
          <p:nvPr/>
        </p:nvCxnSpPr>
        <p:spPr>
          <a:xfrm flipV="1">
            <a:off x="568230" y="2169649"/>
            <a:ext cx="5626093" cy="1167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466B4E5B-04AD-9E0B-BC58-76A6298261D4}"/>
              </a:ext>
            </a:extLst>
          </p:cNvPr>
          <p:cNvSpPr txBox="1"/>
          <p:nvPr/>
        </p:nvSpPr>
        <p:spPr>
          <a:xfrm>
            <a:off x="1097142" y="380627"/>
            <a:ext cx="4539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ry Figure 3 May 2021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40D5379-8703-10AE-C82F-41B4F7BD2455}"/>
              </a:ext>
            </a:extLst>
          </p:cNvPr>
          <p:cNvGrpSpPr/>
          <p:nvPr/>
        </p:nvGrpSpPr>
        <p:grpSpPr>
          <a:xfrm>
            <a:off x="6095993" y="688404"/>
            <a:ext cx="6121887" cy="4630326"/>
            <a:chOff x="5916231" y="1377517"/>
            <a:chExt cx="6121887" cy="4630326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2AD648C1-2836-DC94-DF41-6F23A5E6328A}"/>
                </a:ext>
              </a:extLst>
            </p:cNvPr>
            <p:cNvGrpSpPr/>
            <p:nvPr/>
          </p:nvGrpSpPr>
          <p:grpSpPr>
            <a:xfrm>
              <a:off x="5916231" y="1825958"/>
              <a:ext cx="4896767" cy="3411870"/>
              <a:chOff x="3119769" y="2793621"/>
              <a:chExt cx="4896767" cy="3411870"/>
            </a:xfrm>
          </p:grpSpPr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51ED408A-1AA4-2F24-474C-49ECF816C162}"/>
                  </a:ext>
                </a:extLst>
              </p:cNvPr>
              <p:cNvSpPr/>
              <p:nvPr/>
            </p:nvSpPr>
            <p:spPr>
              <a:xfrm>
                <a:off x="3364637" y="5051394"/>
                <a:ext cx="4651899" cy="1154097"/>
              </a:xfrm>
              <a:prstGeom prst="ellipse">
                <a:avLst/>
              </a:prstGeom>
              <a:solidFill>
                <a:srgbClr val="99663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16" name="Picture 15" descr="A close up of a plant&#10;&#10;Description automatically generated with low confidence">
                <a:extLst>
                  <a:ext uri="{FF2B5EF4-FFF2-40B4-BE49-F238E27FC236}">
                    <a16:creationId xmlns:a16="http://schemas.microsoft.com/office/drawing/2014/main" id="{033AA2E1-0D6E-55AC-A9DD-52E1538024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119769" y="2849732"/>
                <a:ext cx="3229985" cy="2688963"/>
              </a:xfrm>
              <a:prstGeom prst="rect">
                <a:avLst/>
              </a:prstGeom>
            </p:spPr>
          </p:pic>
          <p:pic>
            <p:nvPicPr>
              <p:cNvPr id="17" name="Picture 16" descr="A close up of a plant&#10;&#10;Description automatically generated with low confidence">
                <a:extLst>
                  <a:ext uri="{FF2B5EF4-FFF2-40B4-BE49-F238E27FC236}">
                    <a16:creationId xmlns:a16="http://schemas.microsoft.com/office/drawing/2014/main" id="{A122E713-125E-D65C-C964-2F4BF61350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345278" y="2793621"/>
                <a:ext cx="3307273" cy="2753305"/>
              </a:xfrm>
              <a:prstGeom prst="rect">
                <a:avLst/>
              </a:prstGeom>
            </p:spPr>
          </p:pic>
          <p:sp>
            <p:nvSpPr>
              <p:cNvPr id="18" name="Freeform: Shape 8">
                <a:extLst>
                  <a:ext uri="{FF2B5EF4-FFF2-40B4-BE49-F238E27FC236}">
                    <a16:creationId xmlns:a16="http://schemas.microsoft.com/office/drawing/2014/main" id="{6D17D3D3-B04A-1034-93B2-98653DBD091D}"/>
                  </a:ext>
                </a:extLst>
              </p:cNvPr>
              <p:cNvSpPr/>
              <p:nvPr/>
            </p:nvSpPr>
            <p:spPr>
              <a:xfrm>
                <a:off x="5385917" y="4935984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Freeform: Shape 9">
                <a:extLst>
                  <a:ext uri="{FF2B5EF4-FFF2-40B4-BE49-F238E27FC236}">
                    <a16:creationId xmlns:a16="http://schemas.microsoft.com/office/drawing/2014/main" id="{EB7C4C6C-DB62-43CA-E91D-95BEED6F0957}"/>
                  </a:ext>
                </a:extLst>
              </p:cNvPr>
              <p:cNvSpPr/>
              <p:nvPr/>
            </p:nvSpPr>
            <p:spPr>
              <a:xfrm>
                <a:off x="7339009" y="4918723"/>
                <a:ext cx="375691" cy="818007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Freeform: Shape 8">
                <a:extLst>
                  <a:ext uri="{FF2B5EF4-FFF2-40B4-BE49-F238E27FC236}">
                    <a16:creationId xmlns:a16="http://schemas.microsoft.com/office/drawing/2014/main" id="{54AF7E91-575E-D071-3979-BE96D77FFC64}"/>
                  </a:ext>
                </a:extLst>
              </p:cNvPr>
              <p:cNvSpPr/>
              <p:nvPr/>
            </p:nvSpPr>
            <p:spPr>
              <a:xfrm>
                <a:off x="5538317" y="5088384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Freeform: Shape 8">
                <a:extLst>
                  <a:ext uri="{FF2B5EF4-FFF2-40B4-BE49-F238E27FC236}">
                    <a16:creationId xmlns:a16="http://schemas.microsoft.com/office/drawing/2014/main" id="{FCFC4E4D-3262-849B-8F58-64C724E66B07}"/>
                  </a:ext>
                </a:extLst>
              </p:cNvPr>
              <p:cNvSpPr/>
              <p:nvPr/>
            </p:nvSpPr>
            <p:spPr>
              <a:xfrm>
                <a:off x="5690717" y="5240784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Freeform: Shape 8">
                <a:extLst>
                  <a:ext uri="{FF2B5EF4-FFF2-40B4-BE49-F238E27FC236}">
                    <a16:creationId xmlns:a16="http://schemas.microsoft.com/office/drawing/2014/main" id="{508427CC-43D1-811B-B5E2-EF534D9A7B76}"/>
                  </a:ext>
                </a:extLst>
              </p:cNvPr>
              <p:cNvSpPr/>
              <p:nvPr/>
            </p:nvSpPr>
            <p:spPr>
              <a:xfrm>
                <a:off x="5894940" y="4951478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Freeform: Shape 8">
                <a:extLst>
                  <a:ext uri="{FF2B5EF4-FFF2-40B4-BE49-F238E27FC236}">
                    <a16:creationId xmlns:a16="http://schemas.microsoft.com/office/drawing/2014/main" id="{82D51C6C-997D-85CC-CA72-20F4664CD7E8}"/>
                  </a:ext>
                </a:extLst>
              </p:cNvPr>
              <p:cNvSpPr/>
              <p:nvPr/>
            </p:nvSpPr>
            <p:spPr>
              <a:xfrm>
                <a:off x="5538317" y="5088384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Freeform: Shape 8">
                <a:extLst>
                  <a:ext uri="{FF2B5EF4-FFF2-40B4-BE49-F238E27FC236}">
                    <a16:creationId xmlns:a16="http://schemas.microsoft.com/office/drawing/2014/main" id="{2153F421-AC18-30FF-53FA-2688E962DF3F}"/>
                  </a:ext>
                </a:extLst>
              </p:cNvPr>
              <p:cNvSpPr/>
              <p:nvPr/>
            </p:nvSpPr>
            <p:spPr>
              <a:xfrm>
                <a:off x="5088380" y="4985422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Freeform: Shape 8">
                <a:extLst>
                  <a:ext uri="{FF2B5EF4-FFF2-40B4-BE49-F238E27FC236}">
                    <a16:creationId xmlns:a16="http://schemas.microsoft.com/office/drawing/2014/main" id="{FB61DBAA-BF7F-B413-DD11-D2B97BD9E315}"/>
                  </a:ext>
                </a:extLst>
              </p:cNvPr>
              <p:cNvSpPr/>
              <p:nvPr/>
            </p:nvSpPr>
            <p:spPr>
              <a:xfrm>
                <a:off x="4638443" y="4882460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Freeform: Shape 8">
                <a:extLst>
                  <a:ext uri="{FF2B5EF4-FFF2-40B4-BE49-F238E27FC236}">
                    <a16:creationId xmlns:a16="http://schemas.microsoft.com/office/drawing/2014/main" id="{FA25BC51-D97E-0755-A282-370AE5077C9D}"/>
                  </a:ext>
                </a:extLst>
              </p:cNvPr>
              <p:cNvSpPr/>
              <p:nvPr/>
            </p:nvSpPr>
            <p:spPr>
              <a:xfrm>
                <a:off x="4912395" y="5024895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Freeform: Shape 8">
                <a:extLst>
                  <a:ext uri="{FF2B5EF4-FFF2-40B4-BE49-F238E27FC236}">
                    <a16:creationId xmlns:a16="http://schemas.microsoft.com/office/drawing/2014/main" id="{9B0ED52F-1625-A47E-82C3-A51A040DC057}"/>
                  </a:ext>
                </a:extLst>
              </p:cNvPr>
              <p:cNvSpPr/>
              <p:nvPr/>
            </p:nvSpPr>
            <p:spPr>
              <a:xfrm>
                <a:off x="4736410" y="5064368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Freeform: Shape 8">
                <a:extLst>
                  <a:ext uri="{FF2B5EF4-FFF2-40B4-BE49-F238E27FC236}">
                    <a16:creationId xmlns:a16="http://schemas.microsoft.com/office/drawing/2014/main" id="{12E5CB4F-B89D-B170-4CDE-63E4AB0DFE34}"/>
                  </a:ext>
                </a:extLst>
              </p:cNvPr>
              <p:cNvSpPr/>
              <p:nvPr/>
            </p:nvSpPr>
            <p:spPr>
              <a:xfrm>
                <a:off x="5832791" y="5100060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Freeform: Shape 8">
                <a:extLst>
                  <a:ext uri="{FF2B5EF4-FFF2-40B4-BE49-F238E27FC236}">
                    <a16:creationId xmlns:a16="http://schemas.microsoft.com/office/drawing/2014/main" id="{6E238778-1447-C1A4-E7F6-5349F7833F8B}"/>
                  </a:ext>
                </a:extLst>
              </p:cNvPr>
              <p:cNvSpPr/>
              <p:nvPr/>
            </p:nvSpPr>
            <p:spPr>
              <a:xfrm>
                <a:off x="6127265" y="5111736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Freeform: Shape 8">
                <a:extLst>
                  <a:ext uri="{FF2B5EF4-FFF2-40B4-BE49-F238E27FC236}">
                    <a16:creationId xmlns:a16="http://schemas.microsoft.com/office/drawing/2014/main" id="{BFD763B3-3D5A-CBBD-17B1-73780EED2A15}"/>
                  </a:ext>
                </a:extLst>
              </p:cNvPr>
              <p:cNvSpPr/>
              <p:nvPr/>
            </p:nvSpPr>
            <p:spPr>
              <a:xfrm>
                <a:off x="6421739" y="5123412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Freeform: Shape 8">
                <a:extLst>
                  <a:ext uri="{FF2B5EF4-FFF2-40B4-BE49-F238E27FC236}">
                    <a16:creationId xmlns:a16="http://schemas.microsoft.com/office/drawing/2014/main" id="{533A8F8B-DF5F-867D-DF9A-4493AFCA0725}"/>
                  </a:ext>
                </a:extLst>
              </p:cNvPr>
              <p:cNvSpPr/>
              <p:nvPr/>
            </p:nvSpPr>
            <p:spPr>
              <a:xfrm>
                <a:off x="5315009" y="5253282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Freeform: Shape 8">
                <a:extLst>
                  <a:ext uri="{FF2B5EF4-FFF2-40B4-BE49-F238E27FC236}">
                    <a16:creationId xmlns:a16="http://schemas.microsoft.com/office/drawing/2014/main" id="{47DE5974-F01F-0A0F-420F-F9AADE2E5728}"/>
                  </a:ext>
                </a:extLst>
              </p:cNvPr>
              <p:cNvSpPr/>
              <p:nvPr/>
            </p:nvSpPr>
            <p:spPr>
              <a:xfrm>
                <a:off x="5829005" y="5296768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Freeform: Shape 8">
                <a:extLst>
                  <a:ext uri="{FF2B5EF4-FFF2-40B4-BE49-F238E27FC236}">
                    <a16:creationId xmlns:a16="http://schemas.microsoft.com/office/drawing/2014/main" id="{F650F1DB-64AC-AA9D-5FB8-FA050A5690DC}"/>
                  </a:ext>
                </a:extLst>
              </p:cNvPr>
              <p:cNvSpPr/>
              <p:nvPr/>
            </p:nvSpPr>
            <p:spPr>
              <a:xfrm>
                <a:off x="6688116" y="5103528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Freeform: Shape 8">
                <a:extLst>
                  <a:ext uri="{FF2B5EF4-FFF2-40B4-BE49-F238E27FC236}">
                    <a16:creationId xmlns:a16="http://schemas.microsoft.com/office/drawing/2014/main" id="{9E89DF70-B59A-7763-AEC5-42E2BA27C7F2}"/>
                  </a:ext>
                </a:extLst>
              </p:cNvPr>
              <p:cNvSpPr/>
              <p:nvPr/>
            </p:nvSpPr>
            <p:spPr>
              <a:xfrm>
                <a:off x="6991429" y="5180563"/>
                <a:ext cx="402614" cy="807868"/>
              </a:xfrm>
              <a:custGeom>
                <a:avLst/>
                <a:gdLst>
                  <a:gd name="connsiteX0" fmla="*/ 337352 w 1802167"/>
                  <a:gd name="connsiteY0" fmla="*/ 133165 h 3923930"/>
                  <a:gd name="connsiteX1" fmla="*/ 381740 w 1802167"/>
                  <a:gd name="connsiteY1" fmla="*/ 124287 h 3923930"/>
                  <a:gd name="connsiteX2" fmla="*/ 435006 w 1802167"/>
                  <a:gd name="connsiteY2" fmla="*/ 88776 h 3923930"/>
                  <a:gd name="connsiteX3" fmla="*/ 523783 w 1802167"/>
                  <a:gd name="connsiteY3" fmla="*/ 62143 h 3923930"/>
                  <a:gd name="connsiteX4" fmla="*/ 550416 w 1802167"/>
                  <a:gd name="connsiteY4" fmla="*/ 35510 h 3923930"/>
                  <a:gd name="connsiteX5" fmla="*/ 736847 w 1802167"/>
                  <a:gd name="connsiteY5" fmla="*/ 8877 h 3923930"/>
                  <a:gd name="connsiteX6" fmla="*/ 807868 w 1802167"/>
                  <a:gd name="connsiteY6" fmla="*/ 0 h 3923930"/>
                  <a:gd name="connsiteX7" fmla="*/ 949911 w 1802167"/>
                  <a:gd name="connsiteY7" fmla="*/ 17755 h 3923930"/>
                  <a:gd name="connsiteX8" fmla="*/ 976544 w 1802167"/>
                  <a:gd name="connsiteY8" fmla="*/ 26633 h 3923930"/>
                  <a:gd name="connsiteX9" fmla="*/ 1038688 w 1802167"/>
                  <a:gd name="connsiteY9" fmla="*/ 44388 h 3923930"/>
                  <a:gd name="connsiteX10" fmla="*/ 1083076 w 1802167"/>
                  <a:gd name="connsiteY10" fmla="*/ 71021 h 3923930"/>
                  <a:gd name="connsiteX11" fmla="*/ 1198486 w 1802167"/>
                  <a:gd name="connsiteY11" fmla="*/ 115409 h 3923930"/>
                  <a:gd name="connsiteX12" fmla="*/ 1225119 w 1802167"/>
                  <a:gd name="connsiteY12" fmla="*/ 133165 h 3923930"/>
                  <a:gd name="connsiteX13" fmla="*/ 1260629 w 1802167"/>
                  <a:gd name="connsiteY13" fmla="*/ 150920 h 3923930"/>
                  <a:gd name="connsiteX14" fmla="*/ 1278385 w 1802167"/>
                  <a:gd name="connsiteY14" fmla="*/ 168675 h 3923930"/>
                  <a:gd name="connsiteX15" fmla="*/ 1322773 w 1802167"/>
                  <a:gd name="connsiteY15" fmla="*/ 186431 h 3923930"/>
                  <a:gd name="connsiteX16" fmla="*/ 1376039 w 1802167"/>
                  <a:gd name="connsiteY16" fmla="*/ 248574 h 3923930"/>
                  <a:gd name="connsiteX17" fmla="*/ 1447060 w 1802167"/>
                  <a:gd name="connsiteY17" fmla="*/ 328473 h 3923930"/>
                  <a:gd name="connsiteX18" fmla="*/ 1473693 w 1802167"/>
                  <a:gd name="connsiteY18" fmla="*/ 346229 h 3923930"/>
                  <a:gd name="connsiteX19" fmla="*/ 1509204 w 1802167"/>
                  <a:gd name="connsiteY19" fmla="*/ 390617 h 3923930"/>
                  <a:gd name="connsiteX20" fmla="*/ 1562470 w 1802167"/>
                  <a:gd name="connsiteY20" fmla="*/ 443883 h 3923930"/>
                  <a:gd name="connsiteX21" fmla="*/ 1571348 w 1802167"/>
                  <a:gd name="connsiteY21" fmla="*/ 470516 h 3923930"/>
                  <a:gd name="connsiteX22" fmla="*/ 1606858 w 1802167"/>
                  <a:gd name="connsiteY22" fmla="*/ 523782 h 3923930"/>
                  <a:gd name="connsiteX23" fmla="*/ 1642369 w 1802167"/>
                  <a:gd name="connsiteY23" fmla="*/ 639192 h 3923930"/>
                  <a:gd name="connsiteX24" fmla="*/ 1686757 w 1802167"/>
                  <a:gd name="connsiteY24" fmla="*/ 727968 h 3923930"/>
                  <a:gd name="connsiteX25" fmla="*/ 1713391 w 1802167"/>
                  <a:gd name="connsiteY25" fmla="*/ 781234 h 3923930"/>
                  <a:gd name="connsiteX26" fmla="*/ 1775534 w 1802167"/>
                  <a:gd name="connsiteY26" fmla="*/ 870011 h 3923930"/>
                  <a:gd name="connsiteX27" fmla="*/ 1802167 w 1802167"/>
                  <a:gd name="connsiteY27" fmla="*/ 1074198 h 3923930"/>
                  <a:gd name="connsiteX28" fmla="*/ 1793290 w 1802167"/>
                  <a:gd name="connsiteY28" fmla="*/ 1677879 h 3923930"/>
                  <a:gd name="connsiteX29" fmla="*/ 1775534 w 1802167"/>
                  <a:gd name="connsiteY29" fmla="*/ 1704512 h 3923930"/>
                  <a:gd name="connsiteX30" fmla="*/ 1766657 w 1802167"/>
                  <a:gd name="connsiteY30" fmla="*/ 1731145 h 3923930"/>
                  <a:gd name="connsiteX31" fmla="*/ 1757779 w 1802167"/>
                  <a:gd name="connsiteY31" fmla="*/ 1837677 h 3923930"/>
                  <a:gd name="connsiteX32" fmla="*/ 1748901 w 1802167"/>
                  <a:gd name="connsiteY32" fmla="*/ 1882066 h 3923930"/>
                  <a:gd name="connsiteX33" fmla="*/ 1731146 w 1802167"/>
                  <a:gd name="connsiteY33" fmla="*/ 1997475 h 3923930"/>
                  <a:gd name="connsiteX34" fmla="*/ 1704513 w 1802167"/>
                  <a:gd name="connsiteY34" fmla="*/ 2112885 h 3923930"/>
                  <a:gd name="connsiteX35" fmla="*/ 1686757 w 1802167"/>
                  <a:gd name="connsiteY35" fmla="*/ 2139518 h 3923930"/>
                  <a:gd name="connsiteX36" fmla="*/ 1669002 w 1802167"/>
                  <a:gd name="connsiteY36" fmla="*/ 2210539 h 3923930"/>
                  <a:gd name="connsiteX37" fmla="*/ 1660124 w 1802167"/>
                  <a:gd name="connsiteY37" fmla="*/ 2246050 h 3923930"/>
                  <a:gd name="connsiteX38" fmla="*/ 1651247 w 1802167"/>
                  <a:gd name="connsiteY38" fmla="*/ 2299316 h 3923930"/>
                  <a:gd name="connsiteX39" fmla="*/ 1633491 w 1802167"/>
                  <a:gd name="connsiteY39" fmla="*/ 2343704 h 3923930"/>
                  <a:gd name="connsiteX40" fmla="*/ 1624614 w 1802167"/>
                  <a:gd name="connsiteY40" fmla="*/ 2379215 h 3923930"/>
                  <a:gd name="connsiteX41" fmla="*/ 1615736 w 1802167"/>
                  <a:gd name="connsiteY41" fmla="*/ 2405848 h 3923930"/>
                  <a:gd name="connsiteX42" fmla="*/ 1606858 w 1802167"/>
                  <a:gd name="connsiteY42" fmla="*/ 2450236 h 3923930"/>
                  <a:gd name="connsiteX43" fmla="*/ 1571348 w 1802167"/>
                  <a:gd name="connsiteY43" fmla="*/ 2521258 h 3923930"/>
                  <a:gd name="connsiteX44" fmla="*/ 1553592 w 1802167"/>
                  <a:gd name="connsiteY44" fmla="*/ 2574524 h 3923930"/>
                  <a:gd name="connsiteX45" fmla="*/ 1544715 w 1802167"/>
                  <a:gd name="connsiteY45" fmla="*/ 2627790 h 3923930"/>
                  <a:gd name="connsiteX46" fmla="*/ 1535837 w 1802167"/>
                  <a:gd name="connsiteY46" fmla="*/ 2654423 h 3923930"/>
                  <a:gd name="connsiteX47" fmla="*/ 1526959 w 1802167"/>
                  <a:gd name="connsiteY47" fmla="*/ 2716567 h 3923930"/>
                  <a:gd name="connsiteX48" fmla="*/ 1500326 w 1802167"/>
                  <a:gd name="connsiteY48" fmla="*/ 2787588 h 3923930"/>
                  <a:gd name="connsiteX49" fmla="*/ 1482571 w 1802167"/>
                  <a:gd name="connsiteY49" fmla="*/ 2849732 h 3923930"/>
                  <a:gd name="connsiteX50" fmla="*/ 1447060 w 1802167"/>
                  <a:gd name="connsiteY50" fmla="*/ 2885242 h 3923930"/>
                  <a:gd name="connsiteX51" fmla="*/ 1429305 w 1802167"/>
                  <a:gd name="connsiteY51" fmla="*/ 2929631 h 3923930"/>
                  <a:gd name="connsiteX52" fmla="*/ 1411550 w 1802167"/>
                  <a:gd name="connsiteY52" fmla="*/ 2965141 h 3923930"/>
                  <a:gd name="connsiteX53" fmla="*/ 1384917 w 1802167"/>
                  <a:gd name="connsiteY53" fmla="*/ 3045040 h 3923930"/>
                  <a:gd name="connsiteX54" fmla="*/ 1376039 w 1802167"/>
                  <a:gd name="connsiteY54" fmla="*/ 3071673 h 3923930"/>
                  <a:gd name="connsiteX55" fmla="*/ 1358284 w 1802167"/>
                  <a:gd name="connsiteY55" fmla="*/ 3107184 h 3923930"/>
                  <a:gd name="connsiteX56" fmla="*/ 1313895 w 1802167"/>
                  <a:gd name="connsiteY56" fmla="*/ 3195961 h 3923930"/>
                  <a:gd name="connsiteX57" fmla="*/ 1278385 w 1802167"/>
                  <a:gd name="connsiteY57" fmla="*/ 3231471 h 3923930"/>
                  <a:gd name="connsiteX58" fmla="*/ 1242874 w 1802167"/>
                  <a:gd name="connsiteY58" fmla="*/ 3284737 h 3923930"/>
                  <a:gd name="connsiteX59" fmla="*/ 1233996 w 1802167"/>
                  <a:gd name="connsiteY59" fmla="*/ 3311370 h 3923930"/>
                  <a:gd name="connsiteX60" fmla="*/ 1216241 w 1802167"/>
                  <a:gd name="connsiteY60" fmla="*/ 3338003 h 3923930"/>
                  <a:gd name="connsiteX61" fmla="*/ 1207363 w 1802167"/>
                  <a:gd name="connsiteY61" fmla="*/ 3391269 h 3923930"/>
                  <a:gd name="connsiteX62" fmla="*/ 1162975 w 1802167"/>
                  <a:gd name="connsiteY62" fmla="*/ 3471168 h 3923930"/>
                  <a:gd name="connsiteX63" fmla="*/ 1127464 w 1802167"/>
                  <a:gd name="connsiteY63" fmla="*/ 3586578 h 3923930"/>
                  <a:gd name="connsiteX64" fmla="*/ 1047565 w 1802167"/>
                  <a:gd name="connsiteY64" fmla="*/ 3657600 h 3923930"/>
                  <a:gd name="connsiteX65" fmla="*/ 985422 w 1802167"/>
                  <a:gd name="connsiteY65" fmla="*/ 3719743 h 3923930"/>
                  <a:gd name="connsiteX66" fmla="*/ 967666 w 1802167"/>
                  <a:gd name="connsiteY66" fmla="*/ 3755254 h 3923930"/>
                  <a:gd name="connsiteX67" fmla="*/ 958789 w 1802167"/>
                  <a:gd name="connsiteY67" fmla="*/ 3781887 h 3923930"/>
                  <a:gd name="connsiteX68" fmla="*/ 870012 w 1802167"/>
                  <a:gd name="connsiteY68" fmla="*/ 3861786 h 3923930"/>
                  <a:gd name="connsiteX69" fmla="*/ 825624 w 1802167"/>
                  <a:gd name="connsiteY69" fmla="*/ 3888419 h 3923930"/>
                  <a:gd name="connsiteX70" fmla="*/ 736847 w 1802167"/>
                  <a:gd name="connsiteY70" fmla="*/ 3897297 h 3923930"/>
                  <a:gd name="connsiteX71" fmla="*/ 701336 w 1802167"/>
                  <a:gd name="connsiteY71" fmla="*/ 3906174 h 3923930"/>
                  <a:gd name="connsiteX72" fmla="*/ 674703 w 1802167"/>
                  <a:gd name="connsiteY72" fmla="*/ 3923930 h 3923930"/>
                  <a:gd name="connsiteX73" fmla="*/ 426128 w 1802167"/>
                  <a:gd name="connsiteY73" fmla="*/ 3915052 h 3923930"/>
                  <a:gd name="connsiteX74" fmla="*/ 355107 w 1802167"/>
                  <a:gd name="connsiteY74" fmla="*/ 3906174 h 3923930"/>
                  <a:gd name="connsiteX75" fmla="*/ 275208 w 1802167"/>
                  <a:gd name="connsiteY75" fmla="*/ 3897297 h 3923930"/>
                  <a:gd name="connsiteX76" fmla="*/ 239697 w 1802167"/>
                  <a:gd name="connsiteY76" fmla="*/ 3870664 h 3923930"/>
                  <a:gd name="connsiteX77" fmla="*/ 204187 w 1802167"/>
                  <a:gd name="connsiteY77" fmla="*/ 3852908 h 3923930"/>
                  <a:gd name="connsiteX78" fmla="*/ 186431 w 1802167"/>
                  <a:gd name="connsiteY78" fmla="*/ 3835153 h 3923930"/>
                  <a:gd name="connsiteX79" fmla="*/ 159798 w 1802167"/>
                  <a:gd name="connsiteY79" fmla="*/ 3817398 h 3923930"/>
                  <a:gd name="connsiteX80" fmla="*/ 142043 w 1802167"/>
                  <a:gd name="connsiteY80" fmla="*/ 3773009 h 3923930"/>
                  <a:gd name="connsiteX81" fmla="*/ 133165 w 1802167"/>
                  <a:gd name="connsiteY81" fmla="*/ 3746376 h 3923930"/>
                  <a:gd name="connsiteX82" fmla="*/ 115410 w 1802167"/>
                  <a:gd name="connsiteY82" fmla="*/ 3719743 h 3923930"/>
                  <a:gd name="connsiteX83" fmla="*/ 79899 w 1802167"/>
                  <a:gd name="connsiteY83" fmla="*/ 3595456 h 3923930"/>
                  <a:gd name="connsiteX84" fmla="*/ 62144 w 1802167"/>
                  <a:gd name="connsiteY84" fmla="*/ 3559945 h 3923930"/>
                  <a:gd name="connsiteX85" fmla="*/ 35511 w 1802167"/>
                  <a:gd name="connsiteY85" fmla="*/ 3471168 h 3923930"/>
                  <a:gd name="connsiteX86" fmla="*/ 17756 w 1802167"/>
                  <a:gd name="connsiteY86" fmla="*/ 3444535 h 3923930"/>
                  <a:gd name="connsiteX87" fmla="*/ 8878 w 1802167"/>
                  <a:gd name="connsiteY87" fmla="*/ 3240349 h 3923930"/>
                  <a:gd name="connsiteX88" fmla="*/ 0 w 1802167"/>
                  <a:gd name="connsiteY88" fmla="*/ 3187083 h 3923930"/>
                  <a:gd name="connsiteX89" fmla="*/ 8878 w 1802167"/>
                  <a:gd name="connsiteY89" fmla="*/ 3062796 h 3923930"/>
                  <a:gd name="connsiteX90" fmla="*/ 26633 w 1802167"/>
                  <a:gd name="connsiteY90" fmla="*/ 3009530 h 3923930"/>
                  <a:gd name="connsiteX91" fmla="*/ 44389 w 1802167"/>
                  <a:gd name="connsiteY91" fmla="*/ 2796466 h 3923930"/>
                  <a:gd name="connsiteX92" fmla="*/ 53266 w 1802167"/>
                  <a:gd name="connsiteY92" fmla="*/ 2752077 h 3923930"/>
                  <a:gd name="connsiteX93" fmla="*/ 71022 w 1802167"/>
                  <a:gd name="connsiteY93" fmla="*/ 2725444 h 3923930"/>
                  <a:gd name="connsiteX94" fmla="*/ 97655 w 1802167"/>
                  <a:gd name="connsiteY94" fmla="*/ 2574524 h 3923930"/>
                  <a:gd name="connsiteX95" fmla="*/ 106532 w 1802167"/>
                  <a:gd name="connsiteY95" fmla="*/ 2547891 h 3923930"/>
                  <a:gd name="connsiteX96" fmla="*/ 115410 w 1802167"/>
                  <a:gd name="connsiteY96" fmla="*/ 2512380 h 3923930"/>
                  <a:gd name="connsiteX97" fmla="*/ 124288 w 1802167"/>
                  <a:gd name="connsiteY97" fmla="*/ 2352582 h 3923930"/>
                  <a:gd name="connsiteX98" fmla="*/ 106532 w 1802167"/>
                  <a:gd name="connsiteY98" fmla="*/ 1944209 h 3923930"/>
                  <a:gd name="connsiteX99" fmla="*/ 97655 w 1802167"/>
                  <a:gd name="connsiteY99" fmla="*/ 1757778 h 3923930"/>
                  <a:gd name="connsiteX100" fmla="*/ 88777 w 1802167"/>
                  <a:gd name="connsiteY100" fmla="*/ 1722267 h 3923930"/>
                  <a:gd name="connsiteX101" fmla="*/ 71022 w 1802167"/>
                  <a:gd name="connsiteY101" fmla="*/ 1651246 h 3923930"/>
                  <a:gd name="connsiteX102" fmla="*/ 79899 w 1802167"/>
                  <a:gd name="connsiteY102" fmla="*/ 1455937 h 3923930"/>
                  <a:gd name="connsiteX103" fmla="*/ 88777 w 1802167"/>
                  <a:gd name="connsiteY103" fmla="*/ 1402671 h 3923930"/>
                  <a:gd name="connsiteX104" fmla="*/ 79899 w 1802167"/>
                  <a:gd name="connsiteY104" fmla="*/ 1003176 h 3923930"/>
                  <a:gd name="connsiteX105" fmla="*/ 62144 w 1802167"/>
                  <a:gd name="connsiteY105" fmla="*/ 976543 h 3923930"/>
                  <a:gd name="connsiteX106" fmla="*/ 44389 w 1802167"/>
                  <a:gd name="connsiteY106" fmla="*/ 923277 h 3923930"/>
                  <a:gd name="connsiteX107" fmla="*/ 53266 w 1802167"/>
                  <a:gd name="connsiteY107" fmla="*/ 790112 h 3923930"/>
                  <a:gd name="connsiteX108" fmla="*/ 71022 w 1802167"/>
                  <a:gd name="connsiteY108" fmla="*/ 727968 h 3923930"/>
                  <a:gd name="connsiteX109" fmla="*/ 79899 w 1802167"/>
                  <a:gd name="connsiteY109" fmla="*/ 612559 h 3923930"/>
                  <a:gd name="connsiteX110" fmla="*/ 106532 w 1802167"/>
                  <a:gd name="connsiteY110" fmla="*/ 523782 h 3923930"/>
                  <a:gd name="connsiteX111" fmla="*/ 124288 w 1802167"/>
                  <a:gd name="connsiteY111" fmla="*/ 426128 h 3923930"/>
                  <a:gd name="connsiteX112" fmla="*/ 150921 w 1802167"/>
                  <a:gd name="connsiteY112" fmla="*/ 381739 h 3923930"/>
                  <a:gd name="connsiteX113" fmla="*/ 204187 w 1802167"/>
                  <a:gd name="connsiteY113" fmla="*/ 275207 h 3923930"/>
                  <a:gd name="connsiteX114" fmla="*/ 230820 w 1802167"/>
                  <a:gd name="connsiteY114" fmla="*/ 266330 h 3923930"/>
                  <a:gd name="connsiteX115" fmla="*/ 257453 w 1802167"/>
                  <a:gd name="connsiteY115" fmla="*/ 248574 h 3923930"/>
                  <a:gd name="connsiteX116" fmla="*/ 284086 w 1802167"/>
                  <a:gd name="connsiteY116" fmla="*/ 239697 h 3923930"/>
                  <a:gd name="connsiteX117" fmla="*/ 292963 w 1802167"/>
                  <a:gd name="connsiteY117" fmla="*/ 213064 h 3923930"/>
                  <a:gd name="connsiteX118" fmla="*/ 310719 w 1802167"/>
                  <a:gd name="connsiteY118" fmla="*/ 195308 h 3923930"/>
                  <a:gd name="connsiteX119" fmla="*/ 328474 w 1802167"/>
                  <a:gd name="connsiteY119" fmla="*/ 159798 h 3923930"/>
                  <a:gd name="connsiteX120" fmla="*/ 337352 w 1802167"/>
                  <a:gd name="connsiteY120" fmla="*/ 133165 h 3923930"/>
                  <a:gd name="connsiteX121" fmla="*/ 337352 w 1802167"/>
                  <a:gd name="connsiteY121" fmla="*/ 133165 h 3923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</a:cxnLst>
                <a:rect l="l" t="t" r="r" b="b"/>
                <a:pathLst>
                  <a:path w="1802167" h="3923930">
                    <a:moveTo>
                      <a:pt x="337352" y="133165"/>
                    </a:moveTo>
                    <a:cubicBezTo>
                      <a:pt x="344750" y="131685"/>
                      <a:pt x="368003" y="130531"/>
                      <a:pt x="381740" y="124287"/>
                    </a:cubicBezTo>
                    <a:cubicBezTo>
                      <a:pt x="401167" y="115457"/>
                      <a:pt x="414762" y="95524"/>
                      <a:pt x="435006" y="88776"/>
                    </a:cubicBezTo>
                    <a:cubicBezTo>
                      <a:pt x="499847" y="67163"/>
                      <a:pt x="470115" y="75560"/>
                      <a:pt x="523783" y="62143"/>
                    </a:cubicBezTo>
                    <a:cubicBezTo>
                      <a:pt x="532661" y="53265"/>
                      <a:pt x="540200" y="42807"/>
                      <a:pt x="550416" y="35510"/>
                    </a:cubicBezTo>
                    <a:cubicBezTo>
                      <a:pt x="604655" y="-3232"/>
                      <a:pt x="673036" y="12631"/>
                      <a:pt x="736847" y="8877"/>
                    </a:cubicBezTo>
                    <a:cubicBezTo>
                      <a:pt x="760521" y="5918"/>
                      <a:pt x="784010" y="0"/>
                      <a:pt x="807868" y="0"/>
                    </a:cubicBezTo>
                    <a:cubicBezTo>
                      <a:pt x="846464" y="0"/>
                      <a:pt x="907673" y="7195"/>
                      <a:pt x="949911" y="17755"/>
                    </a:cubicBezTo>
                    <a:cubicBezTo>
                      <a:pt x="958989" y="20025"/>
                      <a:pt x="967581" y="23944"/>
                      <a:pt x="976544" y="26633"/>
                    </a:cubicBezTo>
                    <a:cubicBezTo>
                      <a:pt x="997179" y="32823"/>
                      <a:pt x="1017973" y="38470"/>
                      <a:pt x="1038688" y="44388"/>
                    </a:cubicBezTo>
                    <a:cubicBezTo>
                      <a:pt x="1053484" y="53266"/>
                      <a:pt x="1067643" y="63304"/>
                      <a:pt x="1083076" y="71021"/>
                    </a:cubicBezTo>
                    <a:cubicBezTo>
                      <a:pt x="1120167" y="89566"/>
                      <a:pt x="1161395" y="96864"/>
                      <a:pt x="1198486" y="115409"/>
                    </a:cubicBezTo>
                    <a:cubicBezTo>
                      <a:pt x="1208029" y="120181"/>
                      <a:pt x="1215855" y="127871"/>
                      <a:pt x="1225119" y="133165"/>
                    </a:cubicBezTo>
                    <a:cubicBezTo>
                      <a:pt x="1236609" y="139731"/>
                      <a:pt x="1249618" y="143579"/>
                      <a:pt x="1260629" y="150920"/>
                    </a:cubicBezTo>
                    <a:cubicBezTo>
                      <a:pt x="1267593" y="155563"/>
                      <a:pt x="1271118" y="164522"/>
                      <a:pt x="1278385" y="168675"/>
                    </a:cubicBezTo>
                    <a:cubicBezTo>
                      <a:pt x="1292221" y="176581"/>
                      <a:pt x="1307977" y="180512"/>
                      <a:pt x="1322773" y="186431"/>
                    </a:cubicBezTo>
                    <a:cubicBezTo>
                      <a:pt x="1389733" y="275709"/>
                      <a:pt x="1311117" y="174377"/>
                      <a:pt x="1376039" y="248574"/>
                    </a:cubicBezTo>
                    <a:cubicBezTo>
                      <a:pt x="1411566" y="289176"/>
                      <a:pt x="1407375" y="294457"/>
                      <a:pt x="1447060" y="328473"/>
                    </a:cubicBezTo>
                    <a:cubicBezTo>
                      <a:pt x="1455161" y="335417"/>
                      <a:pt x="1466148" y="338684"/>
                      <a:pt x="1473693" y="346229"/>
                    </a:cubicBezTo>
                    <a:cubicBezTo>
                      <a:pt x="1487091" y="359627"/>
                      <a:pt x="1496458" y="376596"/>
                      <a:pt x="1509204" y="390617"/>
                    </a:cubicBezTo>
                    <a:cubicBezTo>
                      <a:pt x="1526095" y="409197"/>
                      <a:pt x="1562470" y="443883"/>
                      <a:pt x="1562470" y="443883"/>
                    </a:cubicBezTo>
                    <a:cubicBezTo>
                      <a:pt x="1565429" y="452761"/>
                      <a:pt x="1566803" y="462336"/>
                      <a:pt x="1571348" y="470516"/>
                    </a:cubicBezTo>
                    <a:cubicBezTo>
                      <a:pt x="1581711" y="489170"/>
                      <a:pt x="1606858" y="523782"/>
                      <a:pt x="1606858" y="523782"/>
                    </a:cubicBezTo>
                    <a:cubicBezTo>
                      <a:pt x="1613118" y="545691"/>
                      <a:pt x="1632255" y="616075"/>
                      <a:pt x="1642369" y="639192"/>
                    </a:cubicBezTo>
                    <a:cubicBezTo>
                      <a:pt x="1655630" y="669503"/>
                      <a:pt x="1671961" y="698376"/>
                      <a:pt x="1686757" y="727968"/>
                    </a:cubicBezTo>
                    <a:cubicBezTo>
                      <a:pt x="1695635" y="745723"/>
                      <a:pt x="1700990" y="765733"/>
                      <a:pt x="1713391" y="781234"/>
                    </a:cubicBezTo>
                    <a:cubicBezTo>
                      <a:pt x="1759680" y="839097"/>
                      <a:pt x="1739152" y="809375"/>
                      <a:pt x="1775534" y="870011"/>
                    </a:cubicBezTo>
                    <a:cubicBezTo>
                      <a:pt x="1804080" y="984192"/>
                      <a:pt x="1791667" y="916684"/>
                      <a:pt x="1802167" y="1074198"/>
                    </a:cubicBezTo>
                    <a:cubicBezTo>
                      <a:pt x="1799208" y="1275425"/>
                      <a:pt x="1801786" y="1476810"/>
                      <a:pt x="1793290" y="1677879"/>
                    </a:cubicBezTo>
                    <a:cubicBezTo>
                      <a:pt x="1792840" y="1688539"/>
                      <a:pt x="1780306" y="1694969"/>
                      <a:pt x="1775534" y="1704512"/>
                    </a:cubicBezTo>
                    <a:cubicBezTo>
                      <a:pt x="1771349" y="1712882"/>
                      <a:pt x="1769616" y="1722267"/>
                      <a:pt x="1766657" y="1731145"/>
                    </a:cubicBezTo>
                    <a:cubicBezTo>
                      <a:pt x="1763698" y="1766656"/>
                      <a:pt x="1761943" y="1802287"/>
                      <a:pt x="1757779" y="1837677"/>
                    </a:cubicBezTo>
                    <a:cubicBezTo>
                      <a:pt x="1756016" y="1852663"/>
                      <a:pt x="1751382" y="1867182"/>
                      <a:pt x="1748901" y="1882066"/>
                    </a:cubicBezTo>
                    <a:cubicBezTo>
                      <a:pt x="1742502" y="1920459"/>
                      <a:pt x="1737545" y="1959082"/>
                      <a:pt x="1731146" y="1997475"/>
                    </a:cubicBezTo>
                    <a:cubicBezTo>
                      <a:pt x="1727876" y="2017096"/>
                      <a:pt x="1709119" y="2105976"/>
                      <a:pt x="1704513" y="2112885"/>
                    </a:cubicBezTo>
                    <a:lnTo>
                      <a:pt x="1686757" y="2139518"/>
                    </a:lnTo>
                    <a:lnTo>
                      <a:pt x="1669002" y="2210539"/>
                    </a:lnTo>
                    <a:cubicBezTo>
                      <a:pt x="1666043" y="2222376"/>
                      <a:pt x="1662130" y="2234015"/>
                      <a:pt x="1660124" y="2246050"/>
                    </a:cubicBezTo>
                    <a:cubicBezTo>
                      <a:pt x="1657165" y="2263805"/>
                      <a:pt x="1655983" y="2281950"/>
                      <a:pt x="1651247" y="2299316"/>
                    </a:cubicBezTo>
                    <a:cubicBezTo>
                      <a:pt x="1647054" y="2314690"/>
                      <a:pt x="1638530" y="2328586"/>
                      <a:pt x="1633491" y="2343704"/>
                    </a:cubicBezTo>
                    <a:cubicBezTo>
                      <a:pt x="1629633" y="2355279"/>
                      <a:pt x="1627966" y="2367483"/>
                      <a:pt x="1624614" y="2379215"/>
                    </a:cubicBezTo>
                    <a:cubicBezTo>
                      <a:pt x="1622043" y="2388213"/>
                      <a:pt x="1618006" y="2396770"/>
                      <a:pt x="1615736" y="2405848"/>
                    </a:cubicBezTo>
                    <a:cubicBezTo>
                      <a:pt x="1612076" y="2420486"/>
                      <a:pt x="1612275" y="2436153"/>
                      <a:pt x="1606858" y="2450236"/>
                    </a:cubicBezTo>
                    <a:cubicBezTo>
                      <a:pt x="1597357" y="2474940"/>
                      <a:pt x="1579718" y="2496148"/>
                      <a:pt x="1571348" y="2521258"/>
                    </a:cubicBezTo>
                    <a:lnTo>
                      <a:pt x="1553592" y="2574524"/>
                    </a:lnTo>
                    <a:cubicBezTo>
                      <a:pt x="1550633" y="2592279"/>
                      <a:pt x="1548620" y="2610218"/>
                      <a:pt x="1544715" y="2627790"/>
                    </a:cubicBezTo>
                    <a:cubicBezTo>
                      <a:pt x="1542685" y="2636925"/>
                      <a:pt x="1537672" y="2645247"/>
                      <a:pt x="1535837" y="2654423"/>
                    </a:cubicBezTo>
                    <a:cubicBezTo>
                      <a:pt x="1531733" y="2674942"/>
                      <a:pt x="1531063" y="2696048"/>
                      <a:pt x="1526959" y="2716567"/>
                    </a:cubicBezTo>
                    <a:cubicBezTo>
                      <a:pt x="1523840" y="2732162"/>
                      <a:pt x="1503171" y="2779054"/>
                      <a:pt x="1500326" y="2787588"/>
                    </a:cubicBezTo>
                    <a:cubicBezTo>
                      <a:pt x="1498816" y="2792118"/>
                      <a:pt x="1487917" y="2842248"/>
                      <a:pt x="1482571" y="2849732"/>
                    </a:cubicBezTo>
                    <a:cubicBezTo>
                      <a:pt x="1472841" y="2863354"/>
                      <a:pt x="1458897" y="2873405"/>
                      <a:pt x="1447060" y="2885242"/>
                    </a:cubicBezTo>
                    <a:cubicBezTo>
                      <a:pt x="1441142" y="2900038"/>
                      <a:pt x="1435777" y="2915068"/>
                      <a:pt x="1429305" y="2929631"/>
                    </a:cubicBezTo>
                    <a:cubicBezTo>
                      <a:pt x="1423930" y="2941724"/>
                      <a:pt x="1416301" y="2952789"/>
                      <a:pt x="1411550" y="2965141"/>
                    </a:cubicBezTo>
                    <a:cubicBezTo>
                      <a:pt x="1401472" y="2991343"/>
                      <a:pt x="1393795" y="3018407"/>
                      <a:pt x="1384917" y="3045040"/>
                    </a:cubicBezTo>
                    <a:cubicBezTo>
                      <a:pt x="1381958" y="3053918"/>
                      <a:pt x="1380224" y="3063303"/>
                      <a:pt x="1376039" y="3071673"/>
                    </a:cubicBezTo>
                    <a:cubicBezTo>
                      <a:pt x="1370121" y="3083510"/>
                      <a:pt x="1363659" y="3095091"/>
                      <a:pt x="1358284" y="3107184"/>
                    </a:cubicBezTo>
                    <a:cubicBezTo>
                      <a:pt x="1340566" y="3147050"/>
                      <a:pt x="1341747" y="3160151"/>
                      <a:pt x="1313895" y="3195961"/>
                    </a:cubicBezTo>
                    <a:cubicBezTo>
                      <a:pt x="1303618" y="3209174"/>
                      <a:pt x="1290222" y="3219634"/>
                      <a:pt x="1278385" y="3231471"/>
                    </a:cubicBezTo>
                    <a:cubicBezTo>
                      <a:pt x="1257275" y="3294798"/>
                      <a:pt x="1287208" y="3218237"/>
                      <a:pt x="1242874" y="3284737"/>
                    </a:cubicBezTo>
                    <a:cubicBezTo>
                      <a:pt x="1237683" y="3292523"/>
                      <a:pt x="1238181" y="3303000"/>
                      <a:pt x="1233996" y="3311370"/>
                    </a:cubicBezTo>
                    <a:cubicBezTo>
                      <a:pt x="1229224" y="3320913"/>
                      <a:pt x="1222159" y="3329125"/>
                      <a:pt x="1216241" y="3338003"/>
                    </a:cubicBezTo>
                    <a:cubicBezTo>
                      <a:pt x="1213282" y="3355758"/>
                      <a:pt x="1214286" y="3374653"/>
                      <a:pt x="1207363" y="3391269"/>
                    </a:cubicBezTo>
                    <a:cubicBezTo>
                      <a:pt x="1172292" y="3475439"/>
                      <a:pt x="1176132" y="3414153"/>
                      <a:pt x="1162975" y="3471168"/>
                    </a:cubicBezTo>
                    <a:cubicBezTo>
                      <a:pt x="1149900" y="3527827"/>
                      <a:pt x="1159566" y="3549890"/>
                      <a:pt x="1127464" y="3586578"/>
                    </a:cubicBezTo>
                    <a:cubicBezTo>
                      <a:pt x="1055840" y="3668435"/>
                      <a:pt x="1111677" y="3599317"/>
                      <a:pt x="1047565" y="3657600"/>
                    </a:cubicBezTo>
                    <a:cubicBezTo>
                      <a:pt x="1025889" y="3677306"/>
                      <a:pt x="998523" y="3693541"/>
                      <a:pt x="985422" y="3719743"/>
                    </a:cubicBezTo>
                    <a:cubicBezTo>
                      <a:pt x="979503" y="3731580"/>
                      <a:pt x="972879" y="3743090"/>
                      <a:pt x="967666" y="3755254"/>
                    </a:cubicBezTo>
                    <a:cubicBezTo>
                      <a:pt x="963980" y="3763855"/>
                      <a:pt x="964404" y="3774401"/>
                      <a:pt x="958789" y="3781887"/>
                    </a:cubicBezTo>
                    <a:cubicBezTo>
                      <a:pt x="942008" y="3804262"/>
                      <a:pt x="893607" y="3845269"/>
                      <a:pt x="870012" y="3861786"/>
                    </a:cubicBezTo>
                    <a:cubicBezTo>
                      <a:pt x="855876" y="3871681"/>
                      <a:pt x="842296" y="3883973"/>
                      <a:pt x="825624" y="3888419"/>
                    </a:cubicBezTo>
                    <a:cubicBezTo>
                      <a:pt x="796888" y="3896082"/>
                      <a:pt x="766439" y="3894338"/>
                      <a:pt x="736847" y="3897297"/>
                    </a:cubicBezTo>
                    <a:cubicBezTo>
                      <a:pt x="725010" y="3900256"/>
                      <a:pt x="712551" y="3901368"/>
                      <a:pt x="701336" y="3906174"/>
                    </a:cubicBezTo>
                    <a:cubicBezTo>
                      <a:pt x="691529" y="3910377"/>
                      <a:pt x="685367" y="3923586"/>
                      <a:pt x="674703" y="3923930"/>
                    </a:cubicBezTo>
                    <a:lnTo>
                      <a:pt x="426128" y="3915052"/>
                    </a:lnTo>
                    <a:lnTo>
                      <a:pt x="355107" y="3906174"/>
                    </a:lnTo>
                    <a:cubicBezTo>
                      <a:pt x="328494" y="3903043"/>
                      <a:pt x="300820" y="3905177"/>
                      <a:pt x="275208" y="3897297"/>
                    </a:cubicBezTo>
                    <a:cubicBezTo>
                      <a:pt x="261066" y="3892946"/>
                      <a:pt x="252244" y="3878506"/>
                      <a:pt x="239697" y="3870664"/>
                    </a:cubicBezTo>
                    <a:cubicBezTo>
                      <a:pt x="228475" y="3863650"/>
                      <a:pt x="215198" y="3860249"/>
                      <a:pt x="204187" y="3852908"/>
                    </a:cubicBezTo>
                    <a:cubicBezTo>
                      <a:pt x="197223" y="3848265"/>
                      <a:pt x="192967" y="3840382"/>
                      <a:pt x="186431" y="3835153"/>
                    </a:cubicBezTo>
                    <a:cubicBezTo>
                      <a:pt x="178099" y="3828488"/>
                      <a:pt x="168676" y="3823316"/>
                      <a:pt x="159798" y="3817398"/>
                    </a:cubicBezTo>
                    <a:cubicBezTo>
                      <a:pt x="153880" y="3802602"/>
                      <a:pt x="147638" y="3787930"/>
                      <a:pt x="142043" y="3773009"/>
                    </a:cubicBezTo>
                    <a:cubicBezTo>
                      <a:pt x="138757" y="3764247"/>
                      <a:pt x="137350" y="3754746"/>
                      <a:pt x="133165" y="3746376"/>
                    </a:cubicBezTo>
                    <a:cubicBezTo>
                      <a:pt x="128393" y="3736833"/>
                      <a:pt x="121328" y="3728621"/>
                      <a:pt x="115410" y="3719743"/>
                    </a:cubicBezTo>
                    <a:cubicBezTo>
                      <a:pt x="109719" y="3696979"/>
                      <a:pt x="92638" y="3620934"/>
                      <a:pt x="79899" y="3595456"/>
                    </a:cubicBezTo>
                    <a:cubicBezTo>
                      <a:pt x="73981" y="3583619"/>
                      <a:pt x="66791" y="3572336"/>
                      <a:pt x="62144" y="3559945"/>
                    </a:cubicBezTo>
                    <a:cubicBezTo>
                      <a:pt x="31158" y="3477315"/>
                      <a:pt x="84073" y="3580435"/>
                      <a:pt x="35511" y="3471168"/>
                    </a:cubicBezTo>
                    <a:cubicBezTo>
                      <a:pt x="31178" y="3461418"/>
                      <a:pt x="23674" y="3453413"/>
                      <a:pt x="17756" y="3444535"/>
                    </a:cubicBezTo>
                    <a:cubicBezTo>
                      <a:pt x="14797" y="3376473"/>
                      <a:pt x="13565" y="3308314"/>
                      <a:pt x="8878" y="3240349"/>
                    </a:cubicBezTo>
                    <a:cubicBezTo>
                      <a:pt x="7639" y="3222391"/>
                      <a:pt x="0" y="3205083"/>
                      <a:pt x="0" y="3187083"/>
                    </a:cubicBezTo>
                    <a:cubicBezTo>
                      <a:pt x="0" y="3145548"/>
                      <a:pt x="2717" y="3103871"/>
                      <a:pt x="8878" y="3062796"/>
                    </a:cubicBezTo>
                    <a:cubicBezTo>
                      <a:pt x="11654" y="3044287"/>
                      <a:pt x="26633" y="3009530"/>
                      <a:pt x="26633" y="3009530"/>
                    </a:cubicBezTo>
                    <a:cubicBezTo>
                      <a:pt x="34419" y="2869393"/>
                      <a:pt x="27446" y="2889656"/>
                      <a:pt x="44389" y="2796466"/>
                    </a:cubicBezTo>
                    <a:cubicBezTo>
                      <a:pt x="47088" y="2781620"/>
                      <a:pt x="47968" y="2766206"/>
                      <a:pt x="53266" y="2752077"/>
                    </a:cubicBezTo>
                    <a:cubicBezTo>
                      <a:pt x="57012" y="2742087"/>
                      <a:pt x="65103" y="2734322"/>
                      <a:pt x="71022" y="2725444"/>
                    </a:cubicBezTo>
                    <a:cubicBezTo>
                      <a:pt x="72250" y="2718077"/>
                      <a:pt x="89683" y="2606411"/>
                      <a:pt x="97655" y="2574524"/>
                    </a:cubicBezTo>
                    <a:cubicBezTo>
                      <a:pt x="99925" y="2565446"/>
                      <a:pt x="103961" y="2556889"/>
                      <a:pt x="106532" y="2547891"/>
                    </a:cubicBezTo>
                    <a:cubicBezTo>
                      <a:pt x="109884" y="2536159"/>
                      <a:pt x="112451" y="2524217"/>
                      <a:pt x="115410" y="2512380"/>
                    </a:cubicBezTo>
                    <a:cubicBezTo>
                      <a:pt x="118369" y="2459114"/>
                      <a:pt x="124288" y="2405930"/>
                      <a:pt x="124288" y="2352582"/>
                    </a:cubicBezTo>
                    <a:cubicBezTo>
                      <a:pt x="124288" y="2051333"/>
                      <a:pt x="130031" y="2108696"/>
                      <a:pt x="106532" y="1944209"/>
                    </a:cubicBezTo>
                    <a:cubicBezTo>
                      <a:pt x="103573" y="1882065"/>
                      <a:pt x="102616" y="1819794"/>
                      <a:pt x="97655" y="1757778"/>
                    </a:cubicBezTo>
                    <a:cubicBezTo>
                      <a:pt x="96682" y="1745616"/>
                      <a:pt x="91424" y="1734178"/>
                      <a:pt x="88777" y="1722267"/>
                    </a:cubicBezTo>
                    <a:cubicBezTo>
                      <a:pt x="74492" y="1657987"/>
                      <a:pt x="86885" y="1698839"/>
                      <a:pt x="71022" y="1651246"/>
                    </a:cubicBezTo>
                    <a:cubicBezTo>
                      <a:pt x="73981" y="1586143"/>
                      <a:pt x="75256" y="1520942"/>
                      <a:pt x="79899" y="1455937"/>
                    </a:cubicBezTo>
                    <a:cubicBezTo>
                      <a:pt x="81181" y="1437982"/>
                      <a:pt x="88777" y="1420671"/>
                      <a:pt x="88777" y="1402671"/>
                    </a:cubicBezTo>
                    <a:cubicBezTo>
                      <a:pt x="88777" y="1269473"/>
                      <a:pt x="88208" y="1136114"/>
                      <a:pt x="79899" y="1003176"/>
                    </a:cubicBezTo>
                    <a:cubicBezTo>
                      <a:pt x="79233" y="992527"/>
                      <a:pt x="66477" y="986293"/>
                      <a:pt x="62144" y="976543"/>
                    </a:cubicBezTo>
                    <a:cubicBezTo>
                      <a:pt x="54543" y="959440"/>
                      <a:pt x="44389" y="923277"/>
                      <a:pt x="44389" y="923277"/>
                    </a:cubicBezTo>
                    <a:cubicBezTo>
                      <a:pt x="47348" y="878889"/>
                      <a:pt x="48609" y="834354"/>
                      <a:pt x="53266" y="790112"/>
                    </a:cubicBezTo>
                    <a:cubicBezTo>
                      <a:pt x="54981" y="773820"/>
                      <a:pt x="65520" y="744473"/>
                      <a:pt x="71022" y="727968"/>
                    </a:cubicBezTo>
                    <a:cubicBezTo>
                      <a:pt x="73981" y="689498"/>
                      <a:pt x="75391" y="650878"/>
                      <a:pt x="79899" y="612559"/>
                    </a:cubicBezTo>
                    <a:cubicBezTo>
                      <a:pt x="82338" y="591827"/>
                      <a:pt x="101758" y="538103"/>
                      <a:pt x="106532" y="523782"/>
                    </a:cubicBezTo>
                    <a:cubicBezTo>
                      <a:pt x="108320" y="511268"/>
                      <a:pt x="115475" y="445957"/>
                      <a:pt x="124288" y="426128"/>
                    </a:cubicBezTo>
                    <a:cubicBezTo>
                      <a:pt x="131296" y="410360"/>
                      <a:pt x="144124" y="397599"/>
                      <a:pt x="150921" y="381739"/>
                    </a:cubicBezTo>
                    <a:cubicBezTo>
                      <a:pt x="172976" y="330276"/>
                      <a:pt x="161526" y="303647"/>
                      <a:pt x="204187" y="275207"/>
                    </a:cubicBezTo>
                    <a:cubicBezTo>
                      <a:pt x="211973" y="270016"/>
                      <a:pt x="221942" y="269289"/>
                      <a:pt x="230820" y="266330"/>
                    </a:cubicBezTo>
                    <a:cubicBezTo>
                      <a:pt x="239698" y="260411"/>
                      <a:pt x="247910" y="253346"/>
                      <a:pt x="257453" y="248574"/>
                    </a:cubicBezTo>
                    <a:cubicBezTo>
                      <a:pt x="265823" y="244389"/>
                      <a:pt x="277469" y="246314"/>
                      <a:pt x="284086" y="239697"/>
                    </a:cubicBezTo>
                    <a:cubicBezTo>
                      <a:pt x="290703" y="233080"/>
                      <a:pt x="288148" y="221088"/>
                      <a:pt x="292963" y="213064"/>
                    </a:cubicBezTo>
                    <a:cubicBezTo>
                      <a:pt x="297269" y="205887"/>
                      <a:pt x="306076" y="202272"/>
                      <a:pt x="310719" y="195308"/>
                    </a:cubicBezTo>
                    <a:cubicBezTo>
                      <a:pt x="318060" y="184297"/>
                      <a:pt x="323261" y="171962"/>
                      <a:pt x="328474" y="159798"/>
                    </a:cubicBezTo>
                    <a:cubicBezTo>
                      <a:pt x="332160" y="151197"/>
                      <a:pt x="334781" y="142163"/>
                      <a:pt x="337352" y="133165"/>
                    </a:cubicBezTo>
                    <a:lnTo>
                      <a:pt x="337352" y="133165"/>
                    </a:lnTo>
                    <a:close/>
                  </a:path>
                </a:pathLst>
              </a:cu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36" name="Picture 35" descr="A close up of a plant&#10;&#10;Description automatically generated with low confidence">
                <a:extLst>
                  <a:ext uri="{FF2B5EF4-FFF2-40B4-BE49-F238E27FC236}">
                    <a16:creationId xmlns:a16="http://schemas.microsoft.com/office/drawing/2014/main" id="{73500BBA-C6AE-5A25-D5BB-BEB46B7232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32424" y="3372194"/>
                <a:ext cx="3307273" cy="2753305"/>
              </a:xfrm>
              <a:prstGeom prst="rect">
                <a:avLst/>
              </a:prstGeom>
            </p:spPr>
          </p:pic>
          <p:pic>
            <p:nvPicPr>
              <p:cNvPr id="37" name="Picture 36" descr="A close up of a plant&#10;&#10;Description automatically generated with low confidence">
                <a:extLst>
                  <a:ext uri="{FF2B5EF4-FFF2-40B4-BE49-F238E27FC236}">
                    <a16:creationId xmlns:a16="http://schemas.microsoft.com/office/drawing/2014/main" id="{6E0121A6-B7BA-67CE-FCC7-ACB97EDE18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18401" y="3365277"/>
                <a:ext cx="3307273" cy="2753305"/>
              </a:xfrm>
              <a:prstGeom prst="rect">
                <a:avLst/>
              </a:prstGeom>
            </p:spPr>
          </p:pic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594FC91-BF8D-9E9F-C330-72ACE1F4EB07}"/>
                </a:ext>
              </a:extLst>
            </p:cNvPr>
            <p:cNvSpPr txBox="1"/>
            <p:nvPr/>
          </p:nvSpPr>
          <p:spPr>
            <a:xfrm rot="1228313">
              <a:off x="10093908" y="3187091"/>
              <a:ext cx="19442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rgbClr val="FF0000"/>
                  </a:solidFill>
                </a:rPr>
                <a:t>Edge</a:t>
              </a:r>
            </a:p>
          </p:txBody>
        </p:sp>
        <p:sp>
          <p:nvSpPr>
            <p:cNvPr id="10" name="Left Brace 9">
              <a:extLst>
                <a:ext uri="{FF2B5EF4-FFF2-40B4-BE49-F238E27FC236}">
                  <a16:creationId xmlns:a16="http://schemas.microsoft.com/office/drawing/2014/main" id="{250F719E-D4B5-FA24-69FA-1B6DECFF9602}"/>
                </a:ext>
              </a:extLst>
            </p:cNvPr>
            <p:cNvSpPr/>
            <p:nvPr/>
          </p:nvSpPr>
          <p:spPr>
            <a:xfrm rot="6669011">
              <a:off x="10494071" y="3112102"/>
              <a:ext cx="313648" cy="1121059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Left Brace 10">
              <a:extLst>
                <a:ext uri="{FF2B5EF4-FFF2-40B4-BE49-F238E27FC236}">
                  <a16:creationId xmlns:a16="http://schemas.microsoft.com/office/drawing/2014/main" id="{ED304D81-B919-AF88-4911-99AEED0C0D71}"/>
                </a:ext>
              </a:extLst>
            </p:cNvPr>
            <p:cNvSpPr/>
            <p:nvPr/>
          </p:nvSpPr>
          <p:spPr>
            <a:xfrm rot="16200000">
              <a:off x="8192141" y="3041810"/>
              <a:ext cx="589815" cy="4651899"/>
            </a:xfrm>
            <a:prstGeom prst="leftBrace">
              <a:avLst>
                <a:gd name="adj1" fmla="val 0"/>
                <a:gd name="adj2" fmla="val 50591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8BAF696-143B-29C8-091D-E69A1768F71B}"/>
                </a:ext>
              </a:extLst>
            </p:cNvPr>
            <p:cNvSpPr txBox="1"/>
            <p:nvPr/>
          </p:nvSpPr>
          <p:spPr>
            <a:xfrm>
              <a:off x="7414863" y="1377517"/>
              <a:ext cx="22623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chemeClr val="accent1"/>
                  </a:solidFill>
                </a:rPr>
                <a:t>        Cente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A8A4367-E26B-9E55-E41B-E55F7AFCEA02}"/>
                </a:ext>
              </a:extLst>
            </p:cNvPr>
            <p:cNvSpPr txBox="1"/>
            <p:nvPr/>
          </p:nvSpPr>
          <p:spPr>
            <a:xfrm>
              <a:off x="7430605" y="5607733"/>
              <a:ext cx="211288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solidFill>
                    <a:schemeClr val="accent1"/>
                  </a:solidFill>
                </a:rPr>
                <a:t>Aggregate</a:t>
              </a:r>
            </a:p>
          </p:txBody>
        </p:sp>
        <p:sp>
          <p:nvSpPr>
            <p:cNvPr id="20" name="Left Brace 19">
              <a:extLst>
                <a:ext uri="{FF2B5EF4-FFF2-40B4-BE49-F238E27FC236}">
                  <a16:creationId xmlns:a16="http://schemas.microsoft.com/office/drawing/2014/main" id="{D49DD052-4BD3-8A8B-1388-681257C09CE5}"/>
                </a:ext>
              </a:extLst>
            </p:cNvPr>
            <p:cNvSpPr/>
            <p:nvPr/>
          </p:nvSpPr>
          <p:spPr>
            <a:xfrm rot="5400000">
              <a:off x="7956498" y="775924"/>
              <a:ext cx="566439" cy="2310256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9224F754-71DD-5FE1-AEB3-B29102390D59}"/>
              </a:ext>
            </a:extLst>
          </p:cNvPr>
          <p:cNvSpPr txBox="1"/>
          <p:nvPr/>
        </p:nvSpPr>
        <p:spPr>
          <a:xfrm>
            <a:off x="1940169" y="5221738"/>
            <a:ext cx="36966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+mj-lt"/>
              </a:rPr>
              <a:t>Salt Marsh Aggregat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901A7B1-C825-F275-B260-113FB4F61349}"/>
              </a:ext>
            </a:extLst>
          </p:cNvPr>
          <p:cNvSpPr txBox="1"/>
          <p:nvPr/>
        </p:nvSpPr>
        <p:spPr>
          <a:xfrm>
            <a:off x="5272978" y="4383738"/>
            <a:ext cx="867851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cs typeface="Times New Roman" panose="02020603050405020304" pitchFamily="18" charset="0"/>
              </a:rPr>
              <a:t>N = 80,</a:t>
            </a:r>
          </a:p>
          <a:p>
            <a:r>
              <a:rPr lang="en-US" sz="1400" b="1" dirty="0">
                <a:cs typeface="Times New Roman" panose="02020603050405020304" pitchFamily="18" charset="0"/>
              </a:rPr>
              <a:t>P&lt;0.0001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1061048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533C345-36E4-78C4-0026-3CDF411AD4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0886"/>
          <a:stretch/>
        </p:blipFill>
        <p:spPr>
          <a:xfrm>
            <a:off x="2286000" y="825500"/>
            <a:ext cx="6028440" cy="5207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9B36595-9A3E-AEF9-ECD0-4A10B8821A3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825" t="41639" b="45326"/>
          <a:stretch/>
        </p:blipFill>
        <p:spPr>
          <a:xfrm>
            <a:off x="6693030" y="650449"/>
            <a:ext cx="1461155" cy="67873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B865F46-2A1B-4EBE-348B-08055F24C8FA}"/>
              </a:ext>
            </a:extLst>
          </p:cNvPr>
          <p:cNvSpPr txBox="1"/>
          <p:nvPr/>
        </p:nvSpPr>
        <p:spPr>
          <a:xfrm>
            <a:off x="145034" y="229798"/>
            <a:ext cx="21409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3066618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Macintosh PowerPoint</Application>
  <PresentationFormat>Widescreen</PresentationFormat>
  <Paragraphs>19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Supplementary figures 1-3, 5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phie George</dc:creator>
  <cp:lastModifiedBy>Sophie George</cp:lastModifiedBy>
  <cp:revision>2</cp:revision>
  <dcterms:created xsi:type="dcterms:W3CDTF">2024-08-14T03:34:03Z</dcterms:created>
  <dcterms:modified xsi:type="dcterms:W3CDTF">2024-08-16T08:32:48Z</dcterms:modified>
</cp:coreProperties>
</file>